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2E089-2A80-4C25-B829-48D3835320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6113D1-2387-4EE0-A85A-8EAD74ED83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CAFAD-0D64-4350-B55C-FF5F024F38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265297-64E4-408B-9C30-60F09FB521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7FAA2-0643-42C0-9800-6F9CEECBAD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BD7EE-7930-4C3B-B565-B4942C8954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CB3BB-E530-4748-9A10-6E3884CE32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377BF-DC83-4E6B-83A6-C35C7A6186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7EE8F-7651-4006-8BEF-84ED34796F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417FD-7907-4385-87B0-09D53EA6C7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F743C-F45B-41AB-B263-E683370917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707B8-1075-4BF9-BC40-FE86C07AD8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E41165-077B-4069-9B67-3B3FA1CA87A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371600" y="1531800"/>
            <a:ext cx="2133720" cy="4572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35 platinum-treated EO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066680" y="4610160"/>
            <a:ext cx="2743200" cy="4572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7-gene optimized mod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762120" y="2933640"/>
            <a:ext cx="3352680" cy="4572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94-gene descriptive signat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216400" y="1530360"/>
            <a:ext cx="3152880" cy="4572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366 independent platinum-treated EO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5" name=""/>
          <p:cNvCxnSpPr>
            <a:stCxn id="46" idx="2"/>
            <a:endCxn id="43" idx="0"/>
          </p:cNvCxnSpPr>
          <p:nvPr/>
        </p:nvCxnSpPr>
        <p:spPr>
          <a:xfrm>
            <a:off x="2438280" y="2554920"/>
            <a:ext cx="360" cy="379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7" name=""/>
          <p:cNvCxnSpPr>
            <a:stCxn id="48" idx="2"/>
            <a:endCxn id="42" idx="0"/>
          </p:cNvCxnSpPr>
          <p:nvPr/>
        </p:nvCxnSpPr>
        <p:spPr>
          <a:xfrm>
            <a:off x="2438280" y="4215960"/>
            <a:ext cx="360" cy="394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6" name=""/>
          <p:cNvSpPr/>
          <p:nvPr/>
        </p:nvSpPr>
        <p:spPr>
          <a:xfrm>
            <a:off x="914400" y="2247840"/>
            <a:ext cx="304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400" spc="-1" strike="noStrike">
                <a:solidFill>
                  <a:srgbClr val="000000"/>
                </a:solidFill>
                <a:latin typeface="Arial"/>
              </a:rPr>
              <a:t>Supervised analysis on PF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914400" y="3695760"/>
            <a:ext cx="3048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400" spc="-1" strike="noStrike">
                <a:solidFill>
                  <a:srgbClr val="000000"/>
                </a:solidFill>
                <a:latin typeface="Arial"/>
              </a:rPr>
              <a:t>Multivariate Cox model with recursive iteratio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39680" y="6286680"/>
            <a:ext cx="2209680" cy="53316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Cases with favourable profi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502000" y="6286680"/>
            <a:ext cx="2209680" cy="53316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Cases with unfavourable profi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1" name=""/>
          <p:cNvCxnSpPr>
            <a:stCxn id="42" idx="2"/>
            <a:endCxn id="49" idx="0"/>
          </p:cNvCxnSpPr>
          <p:nvPr/>
        </p:nvCxnSpPr>
        <p:spPr>
          <a:xfrm flipH="1">
            <a:off x="1244520" y="5067360"/>
            <a:ext cx="1194120" cy="12196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"/>
          <p:cNvCxnSpPr>
            <a:stCxn id="42" idx="2"/>
            <a:endCxn id="50" idx="0"/>
          </p:cNvCxnSpPr>
          <p:nvPr/>
        </p:nvCxnSpPr>
        <p:spPr>
          <a:xfrm>
            <a:off x="2438280" y="5067360"/>
            <a:ext cx="1168920" cy="12196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3" name=""/>
          <p:cNvSpPr/>
          <p:nvPr/>
        </p:nvSpPr>
        <p:spPr>
          <a:xfrm>
            <a:off x="1647720" y="5676840"/>
            <a:ext cx="160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600" spc="-1" strike="noStrike">
                <a:solidFill>
                  <a:srgbClr val="000000"/>
                </a:solidFill>
                <a:latin typeface="Arial"/>
              </a:rPr>
              <a:t>Linear predicto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759200" y="3114720"/>
            <a:ext cx="1876680" cy="58104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Cases with favourable profi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6897600" y="3114720"/>
            <a:ext cx="2238480" cy="58104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Cases with unfavourable profi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6" name=""/>
          <p:cNvCxnSpPr>
            <a:stCxn id="44" idx="2"/>
            <a:endCxn id="54" idx="0"/>
          </p:cNvCxnSpPr>
          <p:nvPr/>
        </p:nvCxnSpPr>
        <p:spPr>
          <a:xfrm flipH="1">
            <a:off x="5697360" y="1987560"/>
            <a:ext cx="1095840" cy="1127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7" name=""/>
          <p:cNvCxnSpPr>
            <a:stCxn id="44" idx="2"/>
            <a:endCxn id="55" idx="0"/>
          </p:cNvCxnSpPr>
          <p:nvPr/>
        </p:nvCxnSpPr>
        <p:spPr>
          <a:xfrm>
            <a:off x="6792840" y="1987560"/>
            <a:ext cx="1224360" cy="1127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8" name=""/>
          <p:cNvSpPr/>
          <p:nvPr/>
        </p:nvSpPr>
        <p:spPr>
          <a:xfrm>
            <a:off x="5321160" y="258120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600" spc="-1" strike="noStrike">
                <a:solidFill>
                  <a:srgbClr val="000000"/>
                </a:solidFill>
                <a:latin typeface="Arial"/>
              </a:rPr>
              <a:t>Linear predicto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9" name=""/>
          <p:cNvCxnSpPr>
            <a:stCxn id="60" idx="0"/>
            <a:endCxn id="44" idx="1"/>
          </p:cNvCxnSpPr>
          <p:nvPr/>
        </p:nvCxnSpPr>
        <p:spPr>
          <a:xfrm flipH="1" flipV="1" rot="5400000">
            <a:off x="4694760" y="1702800"/>
            <a:ext cx="465480" cy="57816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0" name=""/>
          <p:cNvSpPr/>
          <p:nvPr/>
        </p:nvSpPr>
        <p:spPr>
          <a:xfrm>
            <a:off x="3495600" y="2224080"/>
            <a:ext cx="228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Validation on O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76200" y="952560"/>
            <a:ext cx="3962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IPC series, learning se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876920" y="961920"/>
            <a:ext cx="3962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ublic validation se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0" y="76320"/>
            <a:ext cx="9144000" cy="39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000" spc="-1" strike="noStrike">
                <a:solidFill>
                  <a:srgbClr val="000000"/>
                </a:solidFill>
                <a:latin typeface="Arial"/>
              </a:rPr>
              <a:t>Supplementary Figure 1: study flowchart</a:t>
            </a:r>
            <a:br>
              <a:rPr sz="2000"/>
            </a:br>
            <a:r>
              <a:rPr b="1" lang="fr-FR" sz="2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(EOC, epithelial ovarian cancer; PFS, progression-free survival; OS, overall surviva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4" name=""/>
          <p:cNvCxnSpPr>
            <a:stCxn id="41" idx="2"/>
            <a:endCxn id="46" idx="0"/>
          </p:cNvCxnSpPr>
          <p:nvPr/>
        </p:nvCxnSpPr>
        <p:spPr>
          <a:xfrm>
            <a:off x="2438280" y="1989000"/>
            <a:ext cx="360" cy="25920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65" name=""/>
          <p:cNvCxnSpPr>
            <a:stCxn id="43" idx="2"/>
            <a:endCxn id="48" idx="0"/>
          </p:cNvCxnSpPr>
          <p:nvPr/>
        </p:nvCxnSpPr>
        <p:spPr>
          <a:xfrm>
            <a:off x="2438280" y="3390840"/>
            <a:ext cx="360" cy="3052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66" name=""/>
          <p:cNvCxnSpPr>
            <a:stCxn id="42" idx="3"/>
          </p:cNvCxnSpPr>
          <p:nvPr/>
        </p:nvCxnSpPr>
        <p:spPr>
          <a:xfrm flipV="1">
            <a:off x="3809880" y="2590560"/>
            <a:ext cx="838800" cy="2248560"/>
          </a:xfrm>
          <a:prstGeom prst="bentConnector3">
            <a:avLst>
              <a:gd name="adj1" fmla="val 63847"/>
            </a:avLst>
          </a:prstGeom>
          <a:ln w="9360">
            <a:solidFill>
              <a:srgbClr val="000000"/>
            </a:solidFill>
            <a:miter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sabatierr</cp:lastModifiedBy>
  <dcterms:modified xsi:type="dcterms:W3CDTF">2011-03-11T09:59:06Z</dcterms:modified>
  <cp:revision>1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